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63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34"/>
    <p:restoredTop sz="94660"/>
  </p:normalViewPr>
  <p:slideViewPr>
    <p:cSldViewPr snapToGrid="0">
      <p:cViewPr varScale="1">
        <p:scale>
          <a:sx n="82" d="100"/>
          <a:sy n="82" d="100"/>
        </p:scale>
        <p:origin x="32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640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588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379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47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706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573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410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729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802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496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392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89B264-48B0-D840-856F-6EADF9081A36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C7EEDE-36DD-0544-BECF-CC95A7C85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868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6DCDAC4-2D35-9E56-9E00-7EC09023161D}"/>
              </a:ext>
            </a:extLst>
          </p:cNvPr>
          <p:cNvSpPr txBox="1"/>
          <p:nvPr/>
        </p:nvSpPr>
        <p:spPr>
          <a:xfrm>
            <a:off x="5864524" y="409494"/>
            <a:ext cx="993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. Fig. 1</a:t>
            </a:r>
          </a:p>
        </p:txBody>
      </p:sp>
      <p:pic>
        <p:nvPicPr>
          <p:cNvPr id="7" name="Picture 6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DCD16AF2-E851-16B8-4EFF-525B7D448A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000" y="384328"/>
            <a:ext cx="4572000" cy="9144000"/>
          </a:xfrm>
          <a:prstGeom prst="rect">
            <a:avLst/>
          </a:prstGeom>
        </p:spPr>
      </p:pic>
      <p:grpSp>
        <p:nvGrpSpPr>
          <p:cNvPr id="28" name="Group 27">
            <a:extLst>
              <a:ext uri="{FF2B5EF4-FFF2-40B4-BE49-F238E27FC236}">
                <a16:creationId xmlns:a16="http://schemas.microsoft.com/office/drawing/2014/main" id="{B301D3AA-C8CF-611D-4D31-EEE13ECFFD85}"/>
              </a:ext>
            </a:extLst>
          </p:cNvPr>
          <p:cNvGrpSpPr/>
          <p:nvPr/>
        </p:nvGrpSpPr>
        <p:grpSpPr>
          <a:xfrm>
            <a:off x="1390666" y="8627981"/>
            <a:ext cx="2590088" cy="995785"/>
            <a:chOff x="1390666" y="8289372"/>
            <a:chExt cx="2590088" cy="995785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A7C90B6A-B9BE-CBEE-F8D4-1445179FDDFF}"/>
                </a:ext>
              </a:extLst>
            </p:cNvPr>
            <p:cNvGrpSpPr/>
            <p:nvPr/>
          </p:nvGrpSpPr>
          <p:grpSpPr>
            <a:xfrm>
              <a:off x="1390666" y="8289372"/>
              <a:ext cx="2590088" cy="920445"/>
              <a:chOff x="1390666" y="8289372"/>
              <a:chExt cx="2590088" cy="920445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EFC91EA6-542A-527C-4E0C-BAA59A651310}"/>
                  </a:ext>
                </a:extLst>
              </p:cNvPr>
              <p:cNvSpPr/>
              <p:nvPr/>
            </p:nvSpPr>
            <p:spPr>
              <a:xfrm>
                <a:off x="1453351" y="8374935"/>
                <a:ext cx="2434363" cy="76906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0CDA8809-B90F-0AF2-44BE-D84E6C7CE044}"/>
                  </a:ext>
                </a:extLst>
              </p:cNvPr>
              <p:cNvSpPr txBox="1"/>
              <p:nvPr/>
            </p:nvSpPr>
            <p:spPr>
              <a:xfrm rot="5400000">
                <a:off x="1195099" y="8484939"/>
                <a:ext cx="6527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HT1080</a:t>
                </a: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74DD188C-4861-D63E-B1CD-8171A7E1EEC2}"/>
                  </a:ext>
                </a:extLst>
              </p:cNvPr>
              <p:cNvSpPr txBox="1"/>
              <p:nvPr/>
            </p:nvSpPr>
            <p:spPr>
              <a:xfrm rot="5400000">
                <a:off x="1308516" y="8504976"/>
                <a:ext cx="69281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SW1353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C816EC07-FF24-D1FF-FC7C-8AA5575B0A3B}"/>
                  </a:ext>
                </a:extLst>
              </p:cNvPr>
              <p:cNvSpPr txBox="1"/>
              <p:nvPr/>
            </p:nvSpPr>
            <p:spPr>
              <a:xfrm rot="5400000">
                <a:off x="1548174" y="8391163"/>
                <a:ext cx="46519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EW8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35EB04B8-9065-9E4B-9525-2D6220576BA8}"/>
                  </a:ext>
                </a:extLst>
              </p:cNvPr>
              <p:cNvSpPr txBox="1"/>
              <p:nvPr/>
            </p:nvSpPr>
            <p:spPr>
              <a:xfrm rot="5400000">
                <a:off x="1697542" y="8379942"/>
                <a:ext cx="44275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LM7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04C4E202-77B2-8903-D9DA-287EAFCD8DE1}"/>
                  </a:ext>
                </a:extLst>
              </p:cNvPr>
              <p:cNvSpPr txBox="1"/>
              <p:nvPr/>
            </p:nvSpPr>
            <p:spPr>
              <a:xfrm rot="5400000">
                <a:off x="1790620" y="8408796"/>
                <a:ext cx="5004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TC32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3A874DF-A74A-9CAA-7BB2-44745BE9CF6C}"/>
                  </a:ext>
                </a:extLst>
              </p:cNvPr>
              <p:cNvSpPr txBox="1"/>
              <p:nvPr/>
            </p:nvSpPr>
            <p:spPr>
              <a:xfrm rot="5400000">
                <a:off x="1874928" y="8443261"/>
                <a:ext cx="56938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A4573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20A74C3D-C45C-2472-D617-BE981767DD61}"/>
                  </a:ext>
                </a:extLst>
              </p:cNvPr>
              <p:cNvSpPr txBox="1"/>
              <p:nvPr/>
            </p:nvSpPr>
            <p:spPr>
              <a:xfrm rot="5400000">
                <a:off x="2024037" y="8408796"/>
                <a:ext cx="5004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TC71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FFAC34E-AB53-32EC-44B1-3D9B440A1556}"/>
                  </a:ext>
                </a:extLst>
              </p:cNvPr>
              <p:cNvSpPr txBox="1"/>
              <p:nvPr/>
            </p:nvSpPr>
            <p:spPr>
              <a:xfrm rot="5400000">
                <a:off x="1937637" y="8618790"/>
                <a:ext cx="9204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MLS-402-91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7636BA7F-6445-F239-23F6-20960661AD83}"/>
                  </a:ext>
                </a:extLst>
              </p:cNvPr>
              <p:cNvSpPr txBox="1"/>
              <p:nvPr/>
            </p:nvSpPr>
            <p:spPr>
              <a:xfrm rot="5400000">
                <a:off x="2321977" y="8479328"/>
                <a:ext cx="64152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HS-SYII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B30D458-8255-6041-5E1C-19B0D9385310}"/>
                  </a:ext>
                </a:extLst>
              </p:cNvPr>
              <p:cNvSpPr txBox="1"/>
              <p:nvPr/>
            </p:nvSpPr>
            <p:spPr>
              <a:xfrm rot="5400000">
                <a:off x="2437553" y="8494557"/>
                <a:ext cx="67197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Lipo246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C27B965-7431-B86F-C4EB-2C4100430F00}"/>
                  </a:ext>
                </a:extLst>
              </p:cNvPr>
              <p:cNvSpPr txBox="1"/>
              <p:nvPr/>
            </p:nvSpPr>
            <p:spPr>
              <a:xfrm rot="5400000">
                <a:off x="2601226" y="8447268"/>
                <a:ext cx="5774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DL221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531D3D6B-29CA-38EC-14A2-FFB171C58CF2}"/>
                  </a:ext>
                </a:extLst>
              </p:cNvPr>
              <p:cNvSpPr txBox="1"/>
              <p:nvPr/>
            </p:nvSpPr>
            <p:spPr>
              <a:xfrm rot="5400000">
                <a:off x="2702956" y="8467306"/>
                <a:ext cx="61747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SW982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1AD9DC3-79BD-39D7-4385-410F4B007CF2}"/>
                  </a:ext>
                </a:extLst>
              </p:cNvPr>
              <p:cNvSpPr txBox="1"/>
              <p:nvPr/>
            </p:nvSpPr>
            <p:spPr>
              <a:xfrm rot="5400000">
                <a:off x="2851459" y="8441658"/>
                <a:ext cx="56618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SYO-1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2986703D-5581-55AC-147C-181E1BC2E837}"/>
                  </a:ext>
                </a:extLst>
              </p:cNvPr>
              <p:cNvSpPr txBox="1"/>
              <p:nvPr/>
            </p:nvSpPr>
            <p:spPr>
              <a:xfrm rot="5400000">
                <a:off x="2881503" y="8525014"/>
                <a:ext cx="73289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HEMCSS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492BAEC-6F1A-853A-6EC5-F1CF7F8DA637}"/>
                  </a:ext>
                </a:extLst>
              </p:cNvPr>
              <p:cNvSpPr txBox="1"/>
              <p:nvPr/>
            </p:nvSpPr>
            <p:spPr>
              <a:xfrm rot="5400000">
                <a:off x="2989190" y="8537036"/>
                <a:ext cx="75693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Lipo863B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BB9DF40-2E73-7561-61FE-4830EFB3A09D}"/>
                  </a:ext>
                </a:extLst>
              </p:cNvPr>
              <p:cNvSpPr txBox="1"/>
              <p:nvPr/>
            </p:nvSpPr>
            <p:spPr>
              <a:xfrm rot="5400000">
                <a:off x="3206437" y="8428834"/>
                <a:ext cx="54053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PLS-1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6FBF2C07-715E-AF90-449D-D334FF4F25F4}"/>
                  </a:ext>
                </a:extLst>
              </p:cNvPr>
              <p:cNvSpPr txBox="1"/>
              <p:nvPr/>
            </p:nvSpPr>
            <p:spPr>
              <a:xfrm rot="5400000">
                <a:off x="3306088" y="8452077"/>
                <a:ext cx="58702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CAL78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0C0FDA2B-6745-21AD-C6D1-FA5427B23504}"/>
                  </a:ext>
                </a:extLst>
              </p:cNvPr>
              <p:cNvSpPr txBox="1"/>
              <p:nvPr/>
            </p:nvSpPr>
            <p:spPr>
              <a:xfrm rot="5400000">
                <a:off x="3350747" y="8536235"/>
                <a:ext cx="75533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Lipo224A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A11F1E0-12AC-5E17-84AF-76DE386BD14D}"/>
                  </a:ext>
                </a:extLst>
              </p:cNvPr>
              <p:cNvSpPr txBox="1"/>
              <p:nvPr/>
            </p:nvSpPr>
            <p:spPr>
              <a:xfrm rot="5400000">
                <a:off x="3471480" y="8537036"/>
                <a:ext cx="75693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Lipo573B</a:t>
                </a:r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C9306B6-7D6D-AB5A-EC21-064224C674CC}"/>
                </a:ext>
              </a:extLst>
            </p:cNvPr>
            <p:cNvSpPr txBox="1"/>
            <p:nvPr/>
          </p:nvSpPr>
          <p:spPr>
            <a:xfrm rot="5400000">
              <a:off x="2022407" y="8656460"/>
              <a:ext cx="99578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MLS-1765-9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879767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15F5AFA-84AB-9344-0801-7943C0EE66B9}"/>
              </a:ext>
            </a:extLst>
          </p:cNvPr>
          <p:cNvSpPr txBox="1"/>
          <p:nvPr/>
        </p:nvSpPr>
        <p:spPr>
          <a:xfrm>
            <a:off x="514350" y="1157102"/>
            <a:ext cx="5986463" cy="10704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supervised hierarchical clustering of drug AUC values after filtering for min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= 0.2 (blue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max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= 0.7 (red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istologi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re indicated: CS = chondrosarcoma, DDLPS = dedifferentiated liposarcoma, ES = Ewing sarcoma, FS = fibrosarcoma, MLPS = myxoid liposarcoma, OS = osteosarcoma, PLPS = pleomorphic liposarcoma, SS = synovial sarcoma     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5647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3</Words>
  <Application>Microsoft Macintosh PowerPoint</Application>
  <PresentationFormat>A4 Paper (210x297 mm)</PresentationFormat>
  <Paragraphs>2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ird,Hannah C</dc:creator>
  <cp:lastModifiedBy>Beird,Hannah C</cp:lastModifiedBy>
  <cp:revision>1</cp:revision>
  <dcterms:created xsi:type="dcterms:W3CDTF">2026-03-24T14:09:11Z</dcterms:created>
  <dcterms:modified xsi:type="dcterms:W3CDTF">2026-03-24T14:10:00Z</dcterms:modified>
</cp:coreProperties>
</file>